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3" d="100"/>
          <a:sy n="53" d="100"/>
        </p:scale>
        <p:origin x="-251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Twelve</a:t>
            </a:r>
            <a:r>
              <a:rPr lang="en-US" baseline="0">
                <a:latin typeface="Arial"/>
                <a:cs typeface="Arial"/>
              </a:rPr>
              <a:t> hours</a:t>
            </a:r>
            <a:endParaRPr lang="en-US">
              <a:latin typeface="Arial"/>
              <a:cs typeface="Arial"/>
            </a:endParaRP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L$14:$L$24</c:f>
              <c:numCache>
                <c:formatCode>General</c:formatCode>
                <c:ptCount val="11"/>
                <c:pt idx="0">
                  <c:v>23.8579</c:v>
                </c:pt>
                <c:pt idx="1">
                  <c:v>18.4615</c:v>
                </c:pt>
                <c:pt idx="2">
                  <c:v>16.2612</c:v>
                </c:pt>
                <c:pt idx="3">
                  <c:v>20.8571</c:v>
                </c:pt>
                <c:pt idx="4">
                  <c:v>15.5481</c:v>
                </c:pt>
                <c:pt idx="5">
                  <c:v>20.6691</c:v>
                </c:pt>
                <c:pt idx="6">
                  <c:v>20.6813</c:v>
                </c:pt>
                <c:pt idx="7">
                  <c:v>22.449</c:v>
                </c:pt>
                <c:pt idx="8">
                  <c:v>18.8067</c:v>
                </c:pt>
                <c:pt idx="9">
                  <c:v>19.7875</c:v>
                </c:pt>
                <c:pt idx="10">
                  <c:v>23.1084</c:v>
                </c:pt>
              </c:numCache>
            </c:numRef>
          </c:xVal>
          <c:yVal>
            <c:numRef>
              <c:f>Sheet11!$AJ$14:$AJ$24</c:f>
              <c:numCache>
                <c:formatCode>General</c:formatCode>
                <c:ptCount val="11"/>
                <c:pt idx="0">
                  <c:v>3.0</c:v>
                </c:pt>
                <c:pt idx="1">
                  <c:v>6.0</c:v>
                </c:pt>
                <c:pt idx="2">
                  <c:v>3.0</c:v>
                </c:pt>
                <c:pt idx="3">
                  <c:v>1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-3.0</c:v>
                </c:pt>
                <c:pt idx="8">
                  <c:v>6.0</c:v>
                </c:pt>
                <c:pt idx="9">
                  <c:v>1.0</c:v>
                </c:pt>
                <c:pt idx="10">
                  <c:v>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6730984"/>
        <c:axId val="2116520632"/>
      </c:scatterChart>
      <c:valAx>
        <c:axId val="2116730984"/>
        <c:scaling>
          <c:orientation val="minMax"/>
          <c:min val="1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REM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6520632"/>
        <c:crosses val="autoZero"/>
        <c:crossBetween val="midCat"/>
      </c:valAx>
      <c:valAx>
        <c:axId val="21165206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673098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Twelve</a:t>
            </a:r>
            <a:r>
              <a:rPr lang="en-US" baseline="0">
                <a:latin typeface="Arial"/>
                <a:cs typeface="Arial"/>
              </a:rPr>
              <a:t> hours</a:t>
            </a:r>
            <a:endParaRPr lang="en-US">
              <a:latin typeface="Arial"/>
              <a:cs typeface="Arial"/>
            </a:endParaRP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L$2:$L$13</c:f>
              <c:numCache>
                <c:formatCode>General</c:formatCode>
                <c:ptCount val="12"/>
                <c:pt idx="0">
                  <c:v>17.3031</c:v>
                </c:pt>
                <c:pt idx="1">
                  <c:v>28.8809</c:v>
                </c:pt>
                <c:pt idx="2">
                  <c:v>20.6738</c:v>
                </c:pt>
                <c:pt idx="3">
                  <c:v>17.5793</c:v>
                </c:pt>
                <c:pt idx="4">
                  <c:v>24.7375</c:v>
                </c:pt>
                <c:pt idx="5">
                  <c:v>19.1781</c:v>
                </c:pt>
                <c:pt idx="6">
                  <c:v>16.4103</c:v>
                </c:pt>
                <c:pt idx="7">
                  <c:v>23.1565</c:v>
                </c:pt>
                <c:pt idx="8">
                  <c:v>26.5416</c:v>
                </c:pt>
                <c:pt idx="9">
                  <c:v>19.6906</c:v>
                </c:pt>
                <c:pt idx="10">
                  <c:v>21.5772</c:v>
                </c:pt>
                <c:pt idx="11">
                  <c:v>16.3435</c:v>
                </c:pt>
              </c:numCache>
            </c:numRef>
          </c:xVal>
          <c:yVal>
            <c:numRef>
              <c:f>Sheet11!$AJ$2:$AJ$13</c:f>
              <c:numCache>
                <c:formatCode>General</c:formatCode>
                <c:ptCount val="12"/>
                <c:pt idx="0">
                  <c:v>7.0</c:v>
                </c:pt>
                <c:pt idx="1">
                  <c:v>3.0</c:v>
                </c:pt>
                <c:pt idx="2">
                  <c:v>3.0</c:v>
                </c:pt>
                <c:pt idx="3">
                  <c:v>2.0</c:v>
                </c:pt>
                <c:pt idx="4">
                  <c:v>3.0</c:v>
                </c:pt>
                <c:pt idx="5">
                  <c:v>4.0</c:v>
                </c:pt>
                <c:pt idx="6">
                  <c:v>5.0</c:v>
                </c:pt>
                <c:pt idx="7">
                  <c:v>1.0</c:v>
                </c:pt>
                <c:pt idx="8">
                  <c:v>4.0</c:v>
                </c:pt>
                <c:pt idx="9">
                  <c:v>5.0</c:v>
                </c:pt>
                <c:pt idx="10">
                  <c:v>-1.0</c:v>
                </c:pt>
                <c:pt idx="11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1362552"/>
        <c:axId val="2116825960"/>
      </c:scatterChart>
      <c:valAx>
        <c:axId val="2031362552"/>
        <c:scaling>
          <c:orientation val="minMax"/>
          <c:min val="1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REM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6825960"/>
        <c:crosses val="autoZero"/>
        <c:crossBetween val="midCat"/>
      </c:valAx>
      <c:valAx>
        <c:axId val="2116825960"/>
        <c:scaling>
          <c:orientation val="minMax"/>
          <c:max val="15.0"/>
          <c:min val="-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31362552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L$14:$L$24</c:f>
              <c:numCache>
                <c:formatCode>General</c:formatCode>
                <c:ptCount val="11"/>
                <c:pt idx="0">
                  <c:v>23.8579</c:v>
                </c:pt>
                <c:pt idx="1">
                  <c:v>18.4615</c:v>
                </c:pt>
                <c:pt idx="2">
                  <c:v>16.2612</c:v>
                </c:pt>
                <c:pt idx="3">
                  <c:v>20.8571</c:v>
                </c:pt>
                <c:pt idx="4">
                  <c:v>15.5481</c:v>
                </c:pt>
                <c:pt idx="5">
                  <c:v>20.6691</c:v>
                </c:pt>
                <c:pt idx="6">
                  <c:v>20.6813</c:v>
                </c:pt>
                <c:pt idx="7">
                  <c:v>22.449</c:v>
                </c:pt>
                <c:pt idx="8">
                  <c:v>18.8067</c:v>
                </c:pt>
                <c:pt idx="9">
                  <c:v>19.7875</c:v>
                </c:pt>
                <c:pt idx="10">
                  <c:v>23.1084</c:v>
                </c:pt>
              </c:numCache>
            </c:numRef>
          </c:xVal>
          <c:yVal>
            <c:numRef>
              <c:f>Sheet11!$AL$14:$AL$24</c:f>
              <c:numCache>
                <c:formatCode>General</c:formatCode>
                <c:ptCount val="11"/>
                <c:pt idx="0">
                  <c:v>-4.0</c:v>
                </c:pt>
                <c:pt idx="1">
                  <c:v>6.0</c:v>
                </c:pt>
                <c:pt idx="2">
                  <c:v>-2.0</c:v>
                </c:pt>
                <c:pt idx="3">
                  <c:v>8.0</c:v>
                </c:pt>
                <c:pt idx="4">
                  <c:v>2.0</c:v>
                </c:pt>
                <c:pt idx="5">
                  <c:v>-7.0</c:v>
                </c:pt>
                <c:pt idx="6">
                  <c:v>-3.0</c:v>
                </c:pt>
                <c:pt idx="7">
                  <c:v>-3.0</c:v>
                </c:pt>
                <c:pt idx="8">
                  <c:v>5.0</c:v>
                </c:pt>
                <c:pt idx="9">
                  <c:v>-1.0</c:v>
                </c:pt>
                <c:pt idx="10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4676760"/>
        <c:axId val="2065765432"/>
      </c:scatterChart>
      <c:valAx>
        <c:axId val="2064676760"/>
        <c:scaling>
          <c:orientation val="minMax"/>
          <c:min val="1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REM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5765432"/>
        <c:crosses val="autoZero"/>
        <c:crossBetween val="midCat"/>
      </c:valAx>
      <c:valAx>
        <c:axId val="2065765432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4676760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L$2:$L$13</c:f>
              <c:numCache>
                <c:formatCode>General</c:formatCode>
                <c:ptCount val="12"/>
                <c:pt idx="0">
                  <c:v>17.3031</c:v>
                </c:pt>
                <c:pt idx="1">
                  <c:v>28.8809</c:v>
                </c:pt>
                <c:pt idx="2">
                  <c:v>20.6738</c:v>
                </c:pt>
                <c:pt idx="3">
                  <c:v>17.5793</c:v>
                </c:pt>
                <c:pt idx="4">
                  <c:v>24.7375</c:v>
                </c:pt>
                <c:pt idx="5">
                  <c:v>19.1781</c:v>
                </c:pt>
                <c:pt idx="6">
                  <c:v>16.4103</c:v>
                </c:pt>
                <c:pt idx="7">
                  <c:v>23.1565</c:v>
                </c:pt>
                <c:pt idx="8">
                  <c:v>26.5416</c:v>
                </c:pt>
                <c:pt idx="9">
                  <c:v>19.6906</c:v>
                </c:pt>
                <c:pt idx="10">
                  <c:v>21.5772</c:v>
                </c:pt>
                <c:pt idx="11">
                  <c:v>16.3435</c:v>
                </c:pt>
              </c:numCache>
            </c:numRef>
          </c:xVal>
          <c:yVal>
            <c:numRef>
              <c:f>Sheet11!$AL$2:$AL$13</c:f>
              <c:numCache>
                <c:formatCode>General</c:formatCode>
                <c:ptCount val="12"/>
                <c:pt idx="0">
                  <c:v>9.0</c:v>
                </c:pt>
                <c:pt idx="1">
                  <c:v>-6.0</c:v>
                </c:pt>
                <c:pt idx="2">
                  <c:v>0.0</c:v>
                </c:pt>
                <c:pt idx="3">
                  <c:v>5.0</c:v>
                </c:pt>
                <c:pt idx="4">
                  <c:v>-1.0</c:v>
                </c:pt>
                <c:pt idx="5">
                  <c:v>14.0</c:v>
                </c:pt>
                <c:pt idx="6">
                  <c:v>-2.0</c:v>
                </c:pt>
                <c:pt idx="7">
                  <c:v>5.0</c:v>
                </c:pt>
                <c:pt idx="8">
                  <c:v>1.0</c:v>
                </c:pt>
                <c:pt idx="9">
                  <c:v>7.0</c:v>
                </c:pt>
                <c:pt idx="10">
                  <c:v>-6.0</c:v>
                </c:pt>
                <c:pt idx="11">
                  <c:v>-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4949720"/>
        <c:axId val="2065651464"/>
      </c:scatterChart>
      <c:valAx>
        <c:axId val="2064949720"/>
        <c:scaling>
          <c:orientation val="minMax"/>
          <c:min val="1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REM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5651464"/>
        <c:crosses val="autoZero"/>
        <c:crossBetween val="midCat"/>
      </c:valAx>
      <c:valAx>
        <c:axId val="20656514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4949720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trendline>
            <c:spPr>
              <a:ln>
                <a:solidFill>
                  <a:schemeClr val="accent2"/>
                </a:solidFill>
              </a:ln>
            </c:spPr>
            <c:trendlineType val="linear"/>
            <c:dispRSqr val="1"/>
            <c:dispEq val="0"/>
            <c:trendlineLbl>
              <c:layout>
                <c:manualLayout>
                  <c:x val="0.153388533669221"/>
                  <c:y val="-0.181166156313794"/>
                </c:manualLayout>
              </c:layout>
              <c:numFmt formatCode="#,##0.00" sourceLinked="0"/>
            </c:trendlineLbl>
          </c:trendline>
          <c:xVal>
            <c:numRef>
              <c:f>Sheet11!$J$14:$J$24</c:f>
              <c:numCache>
                <c:formatCode>General</c:formatCode>
                <c:ptCount val="11"/>
                <c:pt idx="0">
                  <c:v>54.4416</c:v>
                </c:pt>
                <c:pt idx="1">
                  <c:v>55.3846</c:v>
                </c:pt>
                <c:pt idx="2">
                  <c:v>57.7465</c:v>
                </c:pt>
                <c:pt idx="3">
                  <c:v>55.4286</c:v>
                </c:pt>
                <c:pt idx="4">
                  <c:v>47.2036</c:v>
                </c:pt>
                <c:pt idx="5">
                  <c:v>54.4803</c:v>
                </c:pt>
                <c:pt idx="6">
                  <c:v>39.0511</c:v>
                </c:pt>
                <c:pt idx="7">
                  <c:v>39.5604</c:v>
                </c:pt>
                <c:pt idx="8">
                  <c:v>61.4786</c:v>
                </c:pt>
                <c:pt idx="9">
                  <c:v>49.004</c:v>
                </c:pt>
                <c:pt idx="10">
                  <c:v>51.9427</c:v>
                </c:pt>
              </c:numCache>
            </c:numRef>
          </c:xVal>
          <c:yVal>
            <c:numRef>
              <c:f>Sheet11!$AJ$14:$AJ$24</c:f>
              <c:numCache>
                <c:formatCode>General</c:formatCode>
                <c:ptCount val="11"/>
                <c:pt idx="0">
                  <c:v>3.0</c:v>
                </c:pt>
                <c:pt idx="1">
                  <c:v>6.0</c:v>
                </c:pt>
                <c:pt idx="2">
                  <c:v>3.0</c:v>
                </c:pt>
                <c:pt idx="3">
                  <c:v>1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-3.0</c:v>
                </c:pt>
                <c:pt idx="8">
                  <c:v>6.0</c:v>
                </c:pt>
                <c:pt idx="9">
                  <c:v>1.0</c:v>
                </c:pt>
                <c:pt idx="10">
                  <c:v>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8497256"/>
        <c:axId val="2103745976"/>
      </c:scatterChart>
      <c:valAx>
        <c:axId val="2128497256"/>
        <c:scaling>
          <c:orientation val="minMax"/>
          <c:min val="3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NREM2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3745976"/>
        <c:crosses val="autoZero"/>
        <c:crossBetween val="midCat"/>
      </c:valAx>
      <c:valAx>
        <c:axId val="21037459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8497256"/>
        <c:crosses val="autoZero"/>
        <c:crossBetween val="midCat"/>
      </c:valAx>
    </c:plotArea>
    <c:legend>
      <c:legendPos val="t"/>
      <c:legendEntry>
        <c:idx val="1"/>
        <c:delete val="1"/>
      </c:legendEntry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J$2:$J$13</c:f>
              <c:numCache>
                <c:formatCode>General</c:formatCode>
                <c:ptCount val="12"/>
                <c:pt idx="0">
                  <c:v>45.8234</c:v>
                </c:pt>
                <c:pt idx="1">
                  <c:v>44.8857</c:v>
                </c:pt>
                <c:pt idx="2">
                  <c:v>35.2221</c:v>
                </c:pt>
                <c:pt idx="3">
                  <c:v>57.4928</c:v>
                </c:pt>
                <c:pt idx="4">
                  <c:v>43.5239</c:v>
                </c:pt>
                <c:pt idx="5">
                  <c:v>40.7045</c:v>
                </c:pt>
                <c:pt idx="6">
                  <c:v>50.1282</c:v>
                </c:pt>
                <c:pt idx="7">
                  <c:v>48.6417</c:v>
                </c:pt>
                <c:pt idx="8">
                  <c:v>56.5684</c:v>
                </c:pt>
                <c:pt idx="9">
                  <c:v>59.353</c:v>
                </c:pt>
                <c:pt idx="10">
                  <c:v>61.5553</c:v>
                </c:pt>
                <c:pt idx="11">
                  <c:v>43.0748</c:v>
                </c:pt>
              </c:numCache>
            </c:numRef>
          </c:xVal>
          <c:yVal>
            <c:numRef>
              <c:f>Sheet11!$AJ$2:$AJ$13</c:f>
              <c:numCache>
                <c:formatCode>General</c:formatCode>
                <c:ptCount val="12"/>
                <c:pt idx="0">
                  <c:v>7.0</c:v>
                </c:pt>
                <c:pt idx="1">
                  <c:v>3.0</c:v>
                </c:pt>
                <c:pt idx="2">
                  <c:v>3.0</c:v>
                </c:pt>
                <c:pt idx="3">
                  <c:v>2.0</c:v>
                </c:pt>
                <c:pt idx="4">
                  <c:v>3.0</c:v>
                </c:pt>
                <c:pt idx="5">
                  <c:v>4.0</c:v>
                </c:pt>
                <c:pt idx="6">
                  <c:v>5.0</c:v>
                </c:pt>
                <c:pt idx="7">
                  <c:v>1.0</c:v>
                </c:pt>
                <c:pt idx="8">
                  <c:v>4.0</c:v>
                </c:pt>
                <c:pt idx="9">
                  <c:v>5.0</c:v>
                </c:pt>
                <c:pt idx="10">
                  <c:v>-1.0</c:v>
                </c:pt>
                <c:pt idx="11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7270184"/>
        <c:axId val="2130136040"/>
      </c:scatterChart>
      <c:valAx>
        <c:axId val="2037270184"/>
        <c:scaling>
          <c:orientation val="minMax"/>
          <c:min val="3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NREM2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0136040"/>
        <c:crosses val="autoZero"/>
        <c:crossBetween val="midCat"/>
      </c:valAx>
      <c:valAx>
        <c:axId val="2130136040"/>
        <c:scaling>
          <c:orientation val="minMax"/>
          <c:max val="15.0"/>
          <c:min val="-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3727018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J$14:$J$24</c:f>
              <c:numCache>
                <c:formatCode>General</c:formatCode>
                <c:ptCount val="11"/>
                <c:pt idx="0">
                  <c:v>54.4416</c:v>
                </c:pt>
                <c:pt idx="1">
                  <c:v>55.3846</c:v>
                </c:pt>
                <c:pt idx="2">
                  <c:v>57.7465</c:v>
                </c:pt>
                <c:pt idx="3">
                  <c:v>55.4286</c:v>
                </c:pt>
                <c:pt idx="4">
                  <c:v>47.2036</c:v>
                </c:pt>
                <c:pt idx="5">
                  <c:v>54.4803</c:v>
                </c:pt>
                <c:pt idx="6">
                  <c:v>39.0511</c:v>
                </c:pt>
                <c:pt idx="7">
                  <c:v>39.5604</c:v>
                </c:pt>
                <c:pt idx="8">
                  <c:v>61.4786</c:v>
                </c:pt>
                <c:pt idx="9">
                  <c:v>49.004</c:v>
                </c:pt>
                <c:pt idx="10">
                  <c:v>51.9427</c:v>
                </c:pt>
              </c:numCache>
            </c:numRef>
          </c:xVal>
          <c:yVal>
            <c:numRef>
              <c:f>Sheet11!$AL$14:$AL$24</c:f>
              <c:numCache>
                <c:formatCode>General</c:formatCode>
                <c:ptCount val="11"/>
                <c:pt idx="0">
                  <c:v>-4.0</c:v>
                </c:pt>
                <c:pt idx="1">
                  <c:v>6.0</c:v>
                </c:pt>
                <c:pt idx="2">
                  <c:v>-2.0</c:v>
                </c:pt>
                <c:pt idx="3">
                  <c:v>8.0</c:v>
                </c:pt>
                <c:pt idx="4">
                  <c:v>2.0</c:v>
                </c:pt>
                <c:pt idx="5">
                  <c:v>-7.0</c:v>
                </c:pt>
                <c:pt idx="6">
                  <c:v>-3.0</c:v>
                </c:pt>
                <c:pt idx="7">
                  <c:v>-3.0</c:v>
                </c:pt>
                <c:pt idx="8">
                  <c:v>5.0</c:v>
                </c:pt>
                <c:pt idx="9">
                  <c:v>-1.0</c:v>
                </c:pt>
                <c:pt idx="10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9748184"/>
        <c:axId val="2127919464"/>
      </c:scatterChart>
      <c:valAx>
        <c:axId val="2129748184"/>
        <c:scaling>
          <c:orientation val="minMax"/>
          <c:min val="3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NREM2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7919464"/>
        <c:crosses val="autoZero"/>
        <c:crossBetween val="midCat"/>
      </c:valAx>
      <c:valAx>
        <c:axId val="2127919464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974818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J$2:$J$13</c:f>
              <c:numCache>
                <c:formatCode>General</c:formatCode>
                <c:ptCount val="12"/>
                <c:pt idx="0">
                  <c:v>45.8234</c:v>
                </c:pt>
                <c:pt idx="1">
                  <c:v>44.8857</c:v>
                </c:pt>
                <c:pt idx="2">
                  <c:v>35.2221</c:v>
                </c:pt>
                <c:pt idx="3">
                  <c:v>57.4928</c:v>
                </c:pt>
                <c:pt idx="4">
                  <c:v>43.5239</c:v>
                </c:pt>
                <c:pt idx="5">
                  <c:v>40.7045</c:v>
                </c:pt>
                <c:pt idx="6">
                  <c:v>50.1282</c:v>
                </c:pt>
                <c:pt idx="7">
                  <c:v>48.6417</c:v>
                </c:pt>
                <c:pt idx="8">
                  <c:v>56.5684</c:v>
                </c:pt>
                <c:pt idx="9">
                  <c:v>59.353</c:v>
                </c:pt>
                <c:pt idx="10">
                  <c:v>61.5553</c:v>
                </c:pt>
                <c:pt idx="11">
                  <c:v>43.0748</c:v>
                </c:pt>
              </c:numCache>
            </c:numRef>
          </c:xVal>
          <c:yVal>
            <c:numRef>
              <c:f>Sheet11!$AL$2:$AL$13</c:f>
              <c:numCache>
                <c:formatCode>General</c:formatCode>
                <c:ptCount val="12"/>
                <c:pt idx="0">
                  <c:v>9.0</c:v>
                </c:pt>
                <c:pt idx="1">
                  <c:v>-6.0</c:v>
                </c:pt>
                <c:pt idx="2">
                  <c:v>0.0</c:v>
                </c:pt>
                <c:pt idx="3">
                  <c:v>5.0</c:v>
                </c:pt>
                <c:pt idx="4">
                  <c:v>-1.0</c:v>
                </c:pt>
                <c:pt idx="5">
                  <c:v>14.0</c:v>
                </c:pt>
                <c:pt idx="6">
                  <c:v>-2.0</c:v>
                </c:pt>
                <c:pt idx="7">
                  <c:v>5.0</c:v>
                </c:pt>
                <c:pt idx="8">
                  <c:v>1.0</c:v>
                </c:pt>
                <c:pt idx="9">
                  <c:v>7.0</c:v>
                </c:pt>
                <c:pt idx="10">
                  <c:v>-6.0</c:v>
                </c:pt>
                <c:pt idx="11">
                  <c:v>-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9367816"/>
        <c:axId val="2129077784"/>
      </c:scatterChart>
      <c:valAx>
        <c:axId val="2129367816"/>
        <c:scaling>
          <c:orientation val="minMax"/>
          <c:min val="30.0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NREM2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9077784"/>
        <c:crosses val="autoZero"/>
        <c:crossBetween val="midCat"/>
      </c:valAx>
      <c:valAx>
        <c:axId val="21290777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9367816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0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68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94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490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357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205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01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179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273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26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9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5AD1E-2944-C540-B7AE-02614D243E21}" type="datetimeFigureOut">
              <a:rPr lang="en-US" smtClean="0"/>
              <a:t>15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13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chart" Target="../charts/chart8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6474993"/>
              </p:ext>
            </p:extLst>
          </p:nvPr>
        </p:nvGraphicFramePr>
        <p:xfrm>
          <a:off x="-178351" y="542384"/>
          <a:ext cx="22771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588557"/>
              </p:ext>
            </p:extLst>
          </p:nvPr>
        </p:nvGraphicFramePr>
        <p:xfrm>
          <a:off x="2098759" y="542384"/>
          <a:ext cx="22771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3444184"/>
              </p:ext>
            </p:extLst>
          </p:nvPr>
        </p:nvGraphicFramePr>
        <p:xfrm>
          <a:off x="-178351" y="3291574"/>
          <a:ext cx="22771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6956317"/>
              </p:ext>
            </p:extLst>
          </p:nvPr>
        </p:nvGraphicFramePr>
        <p:xfrm>
          <a:off x="2118762" y="3292539"/>
          <a:ext cx="22771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3565767"/>
              </p:ext>
            </p:extLst>
          </p:nvPr>
        </p:nvGraphicFramePr>
        <p:xfrm>
          <a:off x="4703047" y="542384"/>
          <a:ext cx="229044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7912188"/>
              </p:ext>
            </p:extLst>
          </p:nvPr>
        </p:nvGraphicFramePr>
        <p:xfrm>
          <a:off x="6993492" y="542384"/>
          <a:ext cx="229044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5357285"/>
              </p:ext>
            </p:extLst>
          </p:nvPr>
        </p:nvGraphicFramePr>
        <p:xfrm>
          <a:off x="4711937" y="3285584"/>
          <a:ext cx="228155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0246203"/>
              </p:ext>
            </p:extLst>
          </p:nvPr>
        </p:nvGraphicFramePr>
        <p:xfrm>
          <a:off x="6990461" y="3292539"/>
          <a:ext cx="228155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403752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88</Words>
  <Application>Microsoft Macintosh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</dc:creator>
  <cp:lastModifiedBy>Kathryn</cp:lastModifiedBy>
  <cp:revision>7</cp:revision>
  <dcterms:created xsi:type="dcterms:W3CDTF">2016-02-23T10:51:08Z</dcterms:created>
  <dcterms:modified xsi:type="dcterms:W3CDTF">2016-06-15T18:18:18Z</dcterms:modified>
</cp:coreProperties>
</file>